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303074-096F-49E5-8D67-E7FDFE6F384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FB46ED-5480-4DAB-89CB-E45C3EA4949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B991F3-8EBB-450E-9DFB-4A536EE2520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04B134-3276-486A-806C-BA28B2FA893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8A1491-DC12-4A34-B318-9DB59B654D3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A7105B-4B41-42DA-8C3A-D9726430B87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560A9C-9C04-4861-852F-6AFF1DA205F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318798-ACD9-4978-9ACB-00D9714A1AC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C05B7F-83C4-4798-857B-3BDB854B25E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BAC8C3-5538-4A3D-8D27-D33B8770843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ED87F8-5567-408D-9163-1D951DEFBCF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273CAC-2595-4F4A-B999-45AF388123A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E6E83A9-592B-4704-8425-8CC20ABE3AC0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345960" y="2095560"/>
            <a:ext cx="2460600" cy="309384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>
            <a:off x="4325400" y="8740800"/>
            <a:ext cx="2474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upplemental Figure 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290520" y="203364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 rot="16200000">
            <a:off x="225000" y="3440880"/>
            <a:ext cx="648720" cy="27648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Event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 flipH="1">
            <a:off x="784080" y="2484360"/>
            <a:ext cx="7920" cy="221004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784080" y="4686480"/>
            <a:ext cx="152424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892080" y="5159520"/>
            <a:ext cx="243000" cy="6120"/>
          </a:xfrm>
          <a:prstGeom prst="line">
            <a:avLst/>
          </a:prstGeom>
          <a:ln w="38160">
            <a:solidFill>
              <a:srgbClr val="0099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0680" bIns="-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893880" y="5311800"/>
            <a:ext cx="242640" cy="648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0320" bIns="-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887400" y="5464080"/>
            <a:ext cx="243000" cy="6480"/>
          </a:xfrm>
          <a:prstGeom prst="line">
            <a:avLst/>
          </a:prstGeom>
          <a:ln w="381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0320" bIns="-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1098360" y="5027760"/>
            <a:ext cx="1086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ntibody contro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1100880" y="5180040"/>
            <a:ext cx="932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5mM glucos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1077120" y="5346720"/>
            <a:ext cx="1171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0 mM D-glucos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1451160" y="2075040"/>
            <a:ext cx="1107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HK-2 cell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4" name="" descr=""/>
          <p:cNvPicPr/>
          <p:nvPr/>
        </p:nvPicPr>
        <p:blipFill>
          <a:blip r:embed="rId2"/>
          <a:stretch/>
        </p:blipFill>
        <p:spPr>
          <a:xfrm>
            <a:off x="3552840" y="2106720"/>
            <a:ext cx="2206440" cy="2941560"/>
          </a:xfrm>
          <a:prstGeom prst="rect">
            <a:avLst/>
          </a:prstGeom>
          <a:ln w="0">
            <a:noFill/>
          </a:ln>
        </p:spPr>
      </p:pic>
      <p:sp>
        <p:nvSpPr>
          <p:cNvPr id="55" name=""/>
          <p:cNvSpPr/>
          <p:nvPr/>
        </p:nvSpPr>
        <p:spPr>
          <a:xfrm>
            <a:off x="3924360" y="4648320"/>
            <a:ext cx="141768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3902040" y="2416320"/>
            <a:ext cx="22320" cy="223200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 rot="16200000">
            <a:off x="3363480" y="3439080"/>
            <a:ext cx="648720" cy="27648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Event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3957480" y="5113440"/>
            <a:ext cx="243000" cy="6120"/>
          </a:xfrm>
          <a:prstGeom prst="line">
            <a:avLst/>
          </a:prstGeom>
          <a:ln w="38160">
            <a:solidFill>
              <a:srgbClr val="0099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0680" bIns="-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3959280" y="5265720"/>
            <a:ext cx="243000" cy="648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0320" bIns="-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3952800" y="5418000"/>
            <a:ext cx="243000" cy="6480"/>
          </a:xfrm>
          <a:prstGeom prst="line">
            <a:avLst/>
          </a:prstGeom>
          <a:ln w="381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0320" bIns="-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4163760" y="4981680"/>
            <a:ext cx="1086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ntibody contro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4166280" y="5133960"/>
            <a:ext cx="932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5mM glucos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4142520" y="5300640"/>
            <a:ext cx="1171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0 mM D-glucos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4461480" y="2076480"/>
            <a:ext cx="927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M1 cell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541440" y="2324160"/>
            <a:ext cx="220680" cy="24444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3651120" y="2239920"/>
            <a:ext cx="220680" cy="24444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4080600" y="4748040"/>
            <a:ext cx="94104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Fluorescenc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986760" y="4809960"/>
            <a:ext cx="94104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Fluorescenc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3407040" y="203364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4-12-08T21:53:14Z</dcterms:created>
  <dc:creator>Erwin P. Bottinger, M.D.</dc:creator>
  <dc:description/>
  <dc:language>en-US</dc:language>
  <cp:lastModifiedBy>Erwin P. Bottinger, M.D.</cp:lastModifiedBy>
  <dcterms:modified xsi:type="dcterms:W3CDTF">2004-12-08T21:54:24Z</dcterms:modified>
  <cp:revision>1</cp:revision>
  <dc:subject/>
  <dc:title>Slide 1</dc:title>
</cp:coreProperties>
</file>